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88AD41-8875-9540-861E-DBF97862C0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005476-7CD4-124E-961A-89BAB83BA5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2A0C61-7C0E-8840-9FD0-3F55854D2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6D3598-559A-D149-9C1C-E7FAE8D13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453C52-859E-1644-A720-06550AC20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41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4FD0F-6B4A-0A48-8D15-24DF87282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67FB04-497D-1C47-AD60-C1DD500E9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9B9D9F-0C68-4B4E-BD49-A53F2900C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29698-B72A-2F4A-8E21-A0ECD7502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821BDF-2B3B-3E4F-8B94-B88BBD9D9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61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4FF11B-34E1-B043-8224-0C8E66CB82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DA3644-365A-3445-A4D5-B9CA64372B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FEC7CE-0A57-274F-B87C-AF3CAB955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CD3743-4B9C-5D4D-89A9-C98F166F3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56F110-D768-E44C-A5B1-EB9747364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95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F28E0-ACCB-C442-82F1-ADCE564C3D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4FB50-EB54-574C-A718-6678487898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5A03B-B9CB-F140-A1EE-DEDD8937D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B03DC6-C451-C240-BF1A-3EE9C83ED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9B228F-012E-2F48-ABB7-0C6FF2AA5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683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E6299-E029-3B4C-BD61-B9AFC2D05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2190D3-2948-3E42-9449-5E8A5E1EC2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3E929D-AF64-3A45-A084-408B2E907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5689EF-4264-A544-8FE2-D406EF3EC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759FC-944F-C84D-A0D1-BF2AEC56D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216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3BAC00-50C2-214B-A277-06C384A2C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FA4D78-6EC7-FC49-A4EA-DD28E687A0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90129A-DEF3-4449-95B0-C7653B3EE2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80EA3A-39DE-E544-B9FB-6C267FE56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89ECF0-8B52-B54B-BC26-1240FAA19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8D7F62-2578-CC45-BB15-B99D743A6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468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8B306-BF0E-4E4E-8035-08437620D7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1153F3-6E29-C746-B507-DEBA24DD29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32F216-BFB4-354F-B5AF-5122C6F3AC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808EB2-3341-4E49-BCA3-AF8D492618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7C6FC3-27E7-BB42-8EC0-EA0F97F7AB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282402-F2D4-6F4E-8827-465743658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E8AF63-D444-3B44-8B75-618DF6601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1CEAED-2F51-564A-980F-624C90E52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41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7786E-B3AB-3C4F-AD50-DADEBB13A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C93622-8A63-2C4C-8F2B-E2D98CEEC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AE13FD-F64C-DB44-A4AD-5E92DA88C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645070-27B3-BB4B-B345-BB322B3B7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83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EF47BC-8F7C-F64C-807C-4327ED064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8B6EDB-6D4D-B44E-A1C8-DC383E39A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79815C-7BCD-9243-BF0C-2DB1A2E1C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433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0F820D-6D7B-0F40-A2AB-9A6A890B3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47D670-ED22-CD42-9C52-82D93DDBD4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9E6B00-E627-DB45-BB74-C079AC21E6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CB589F-001F-C344-976D-1D6850858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BBD25-64EE-0C4D-855A-F7603B01B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192C41-370E-3448-96A3-710834C9C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58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F81C24-6A84-2A49-BA12-C4091C682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9C0A53-D0E1-A342-AA72-EE9498CA4D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9F9A9A-0FB0-0D4C-B93B-302938974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9B9FA2-27D2-2942-AA20-5AF366211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DF468F-C575-494C-B4D4-D02ED4546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3D7C51-6758-DC46-B410-10A1521BF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261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821AF9-6541-394C-A53F-17B55ECBE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1361F6-AFF9-3242-A056-94CCBAE1DA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139E6-A393-4140-8BE2-BC3F327317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2A4EE-56DF-CE47-B7F4-700A3FD809E7}" type="datetimeFigureOut">
              <a:rPr lang="en-US" smtClean="0"/>
              <a:t>4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48162B-53CD-3C49-A96A-05952FEEC5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82A588-644B-1E47-B8F1-2BF1BA0005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92F24-6F6E-4844-BF0B-2692B8459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332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BEBE368-15E7-0C44-80F7-EB5B3444FD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464" y="412750"/>
            <a:ext cx="6159500" cy="6032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0BACFC5-6A54-CB41-A8F0-3F9AE75AECC3}"/>
              </a:ext>
            </a:extLst>
          </p:cNvPr>
          <p:cNvSpPr txBox="1"/>
          <p:nvPr/>
        </p:nvSpPr>
        <p:spPr>
          <a:xfrm>
            <a:off x="7304690" y="1975945"/>
            <a:ext cx="393086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 a) NRM, b) RI, c) LFS and d) OS from time of transplant for patients with AML with </a:t>
            </a:r>
            <a:r>
              <a:rPr lang="en-US" b="1" i="1" dirty="0"/>
              <a:t>TP53 </a:t>
            </a:r>
            <a:r>
              <a:rPr lang="en-US" b="1" dirty="0"/>
              <a:t>mutations. MAC, myeloablative conditioning, RIC, Reduced </a:t>
            </a:r>
            <a:r>
              <a:rPr lang="en-US" b="1" dirty="0" err="1"/>
              <a:t>Intenstity</a:t>
            </a:r>
            <a:r>
              <a:rPr lang="en-US" b="1" dirty="0"/>
              <a:t> Conditioning. NRM, non-relapse mortality; RI, relapse incidence; LFS, </a:t>
            </a:r>
            <a:r>
              <a:rPr lang="en-US" b="1" dirty="0" err="1"/>
              <a:t>leukaemia</a:t>
            </a:r>
            <a:r>
              <a:rPr lang="en-US" b="1" dirty="0"/>
              <a:t> free survival; OS, overall survival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540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ke, Ching</dc:creator>
  <cp:lastModifiedBy>Loke, Ching</cp:lastModifiedBy>
  <cp:revision>1</cp:revision>
  <dcterms:created xsi:type="dcterms:W3CDTF">2022-04-08T19:45:57Z</dcterms:created>
  <dcterms:modified xsi:type="dcterms:W3CDTF">2022-04-08T19:48:28Z</dcterms:modified>
</cp:coreProperties>
</file>